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  <p:sldMasterId id="2147483660" r:id="rId2"/>
  </p:sldMasterIdLst>
  <p:notesMasterIdLst>
    <p:notesMasterId r:id="rId7"/>
  </p:notesMasterIdLst>
  <p:sldIdLst>
    <p:sldId id="1993220262" r:id="rId3"/>
    <p:sldId id="1993220267" r:id="rId4"/>
    <p:sldId id="1993220268" r:id="rId5"/>
    <p:sldId id="1993220266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63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7167A25-876A-82DC-37A7-10158C9AF53A}" name="正嗣 大原" initials="正大" userId="0c08755f5c0dfc25" providerId="Windows Live"/>
  <p188:author id="{2BF902E4-DB05-3BBC-ABB0-FEC3F2F2A1F6}" name="崇倫 田中" initials="崇田" userId="96b8371cc7247123" providerId="Windows Live"/>
  <p188:author id="{E94806F5-F1DD-79F5-3D8D-85F6927CF9C2}" name="Author" initials="AA" userId="Author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484" autoAdjust="0"/>
    <p:restoredTop sz="94577"/>
  </p:normalViewPr>
  <p:slideViewPr>
    <p:cSldViewPr snapToGrid="0" showGuides="1">
      <p:cViewPr varScale="1">
        <p:scale>
          <a:sx n="110" d="100"/>
          <a:sy n="110" d="100"/>
        </p:scale>
        <p:origin x="216" y="312"/>
      </p:cViewPr>
      <p:guideLst>
        <p:guide orient="horz" pos="2160"/>
        <p:guide pos="386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notesMaster" Target="notesMasters/notesMaster1.xml"/><Relationship Id="rId12" Type="http://schemas.microsoft.com/office/2018/10/relationships/authors" Target="author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ableStyles" Target="tableStyles.xml"/><Relationship Id="rId5" Type="http://schemas.openxmlformats.org/officeDocument/2006/relationships/slide" Target="slides/slide3.xml"/><Relationship Id="rId10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A58767-365E-AA4A-BC53-8AAE13EC5F91}" type="datetimeFigureOut">
              <a:rPr kumimoji="1" lang="ja-JP" altLang="en-US" smtClean="0"/>
              <a:t>2026/2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E273A8-9D66-D446-960C-1B64842082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10492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D391D91-6650-6825-F084-22130771653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33A80BDA-5C1A-E687-399C-677644BDB44B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366C51C2-D51E-D56B-E459-857841DAEB6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altLang="ja-JP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FF17DB6-DF08-6970-B7E6-1676C6FFD01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16AC6E-5AFC-2843-A33D-EDB9BD55118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187464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0FEF579-A9A9-FCBB-E86B-C428F983C2E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20FDF226-343D-8F99-3327-D934621D2A8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598C4960-7B34-A77F-C675-6D9D71CEC79E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altLang="ja-JP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4F40091-9B8A-A69F-38EE-5DCCC24F76E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16AC6E-5AFC-2843-A33D-EDB9BD55118F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036232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B7EC837-3507-0C2E-74A7-0EE506DD921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35FFF4F4-D5F7-49B7-8E29-AD8274C7C30A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34EBB409-A3F9-AD52-4128-E76AFA8C1C9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altLang="ja-JP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7BD93A0-6208-F3E6-6417-1B18CAE8351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16AC6E-5AFC-2843-A33D-EDB9BD55118F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860135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5290617-E801-E138-043D-BA6BCF39C51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EAB178E9-FE6D-E91D-EEEB-FD9A64E00AD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5E0CC276-9AD5-9B42-EE05-93C79F75F5F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(a)HCC OS </a:t>
            </a:r>
            <a:r>
              <a:rPr kumimoji="1" lang="en-US" altLang="ja-JP" dirty="0" err="1"/>
              <a:t>Logrank</a:t>
            </a:r>
            <a:r>
              <a:rPr kumimoji="1" lang="en-US" altLang="ja-JP" dirty="0"/>
              <a:t> (b) No HCC </a:t>
            </a:r>
            <a:r>
              <a:rPr kumimoji="1" lang="en-US" altLang="ja-JP" dirty="0" err="1"/>
              <a:t>Logrank</a:t>
            </a:r>
            <a:endParaRPr kumimoji="1" lang="en-US" altLang="ja-JP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C504FAF-40D7-3C24-B736-6D7C1BB5205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16AC6E-5AFC-2843-A33D-EDB9BD55118F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85908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C959929-99A8-C98A-FD9F-B453D6B522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37F7342-4756-D28B-F90B-4EF03D47684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E6357C6-40A1-9FED-7781-3EBDD01A56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0348-816D-BB46-AFBB-38E640A4E6AD}" type="datetimeFigureOut">
              <a:rPr kumimoji="1" lang="ja-JP" altLang="en-US" smtClean="0"/>
              <a:t>2026/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63A8A4D-67FC-7988-D601-D34262C934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1F88439-D535-2D4C-AB81-A7CDE07776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6210-0803-F845-8C25-9090BCE3B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2910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98A3EFB-EFD6-6BDE-9597-296576E323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85A4686-D19C-D14C-364B-8307D31B6F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91BBF2A-C5E3-B1E6-A697-33394822A3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0348-816D-BB46-AFBB-38E640A4E6AD}" type="datetimeFigureOut">
              <a:rPr kumimoji="1" lang="ja-JP" altLang="en-US" smtClean="0"/>
              <a:t>2026/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948A0B3-667A-B3AB-49BE-D1782F2FEF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2CCFBB-01A8-4BE4-9AED-0A9514FB26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6210-0803-F845-8C25-9090BCE3B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6613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74E7C01-9094-188B-DE68-7C31F9EF19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298F58F-10F0-2537-8538-4E4442CABB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12092DA-CE04-C877-3972-6175CB1964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0348-816D-BB46-AFBB-38E640A4E6AD}" type="datetimeFigureOut">
              <a:rPr kumimoji="1" lang="ja-JP" altLang="en-US" smtClean="0"/>
              <a:t>2026/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50D9D5B-6669-A159-B8D3-EBB6BB40F7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D8FA7F1-0629-8819-85E7-AA1E682CC4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6210-0803-F845-8C25-9090BCE3B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369301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5" name="Rectangle 7"/>
          <p:cNvSpPr>
            <a:spLocks noChangeArrowheads="1"/>
          </p:cNvSpPr>
          <p:nvPr/>
        </p:nvSpPr>
        <p:spPr bwMode="auto">
          <a:xfrm>
            <a:off x="1" y="1917700"/>
            <a:ext cx="2351617" cy="2735263"/>
          </a:xfrm>
          <a:prstGeom prst="rect">
            <a:avLst/>
          </a:prstGeom>
          <a:solidFill>
            <a:srgbClr val="9CB66D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endParaRPr lang="ja-JP" altLang="ja-JP" sz="1800"/>
          </a:p>
        </p:txBody>
      </p:sp>
      <p:sp>
        <p:nvSpPr>
          <p:cNvPr id="12296" name="Rectangle 8"/>
          <p:cNvSpPr>
            <a:spLocks noChangeArrowheads="1"/>
          </p:cNvSpPr>
          <p:nvPr/>
        </p:nvSpPr>
        <p:spPr bwMode="auto">
          <a:xfrm>
            <a:off x="2332568" y="1917700"/>
            <a:ext cx="9859433" cy="2735263"/>
          </a:xfrm>
          <a:prstGeom prst="rect">
            <a:avLst/>
          </a:prstGeom>
          <a:solidFill>
            <a:srgbClr val="23651C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endParaRPr lang="ja-JP" altLang="ja-JP" sz="1800"/>
          </a:p>
        </p:txBody>
      </p:sp>
      <p:sp>
        <p:nvSpPr>
          <p:cNvPr id="1229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2495552" y="2014538"/>
            <a:ext cx="9264649" cy="1152525"/>
          </a:xfrm>
        </p:spPr>
        <p:txBody>
          <a:bodyPr anchor="t"/>
          <a:lstStyle>
            <a:lvl1pPr>
              <a:defRPr sz="3800"/>
            </a:lvl1pPr>
          </a:lstStyle>
          <a:p>
            <a:pPr lvl="0"/>
            <a:r>
              <a:rPr lang="ja-JP" altLang="en-US" noProof="0"/>
              <a:t>マスター タイトルの書式設定</a:t>
            </a:r>
          </a:p>
        </p:txBody>
      </p:sp>
      <p:sp>
        <p:nvSpPr>
          <p:cNvPr id="12291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2497667" y="3238501"/>
            <a:ext cx="9262533" cy="576263"/>
          </a:xfrm>
        </p:spPr>
        <p:txBody>
          <a:bodyPr/>
          <a:lstStyle>
            <a:lvl1pPr marL="0" indent="0">
              <a:defRPr sz="2400">
                <a:solidFill>
                  <a:schemeClr val="bg1"/>
                </a:solidFill>
              </a:defRPr>
            </a:lvl1pPr>
          </a:lstStyle>
          <a:p>
            <a:pPr lvl="0"/>
            <a:r>
              <a:rPr lang="ja-JP" altLang="en-US" noProof="0"/>
              <a:t>マスター サブタイトルの書式設定</a:t>
            </a:r>
          </a:p>
        </p:txBody>
      </p:sp>
      <p:pic>
        <p:nvPicPr>
          <p:cNvPr id="12304" name="Picture 16" descr="logomark1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9685" y="274639"/>
            <a:ext cx="3281704" cy="9937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41244948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>
          <p15:clr>
            <a:srgbClr val="FBAE40"/>
          </p15:clr>
        </p15:guide>
        <p15:guide id="2" pos="2880">
          <p15:clr>
            <a:srgbClr val="FBAE40"/>
          </p15:clr>
        </p15:guide>
      </p15:sldGuideLst>
    </p:ext>
  </p:extLst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fld id="{7B3644E8-39D6-41C9-8C03-5DF29F5A831C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46598437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1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1" y="4589464"/>
            <a:ext cx="10515600" cy="1500187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fld id="{3EAA9C5E-9952-4585-ACC4-DEECB2074698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21770852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39184" y="1125538"/>
            <a:ext cx="5755216" cy="496728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97601" y="1125538"/>
            <a:ext cx="5755217" cy="496728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fld id="{1179CCC7-9778-4FDF-8EC8-6FAE03C955EA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71344967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40317" y="365126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40318" y="1681163"/>
            <a:ext cx="5158316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40318" y="2505075"/>
            <a:ext cx="5158316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71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71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fld id="{47193069-9D1F-4ED2-BE43-35ACD300BD4B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05226242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スライド番号プレースホルダー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fld id="{4AE9B4F6-F1FF-417F-AAD6-BB1453C32ADA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009075092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番号プレースホルダー 1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fld id="{BCF9C666-1A9B-4A7C-B5A2-8872B6147806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16585754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40318" y="457200"/>
            <a:ext cx="393276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717" y="987426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40318" y="2057400"/>
            <a:ext cx="393276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fld id="{CB17A85C-1E41-422B-BD61-7747E209F22D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3707032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3CD978-136E-7129-6C23-32BA46D07A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B8289B5-A583-13E5-5CE2-AB9D2F230C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4DD1F0E-5CBF-2B32-5E69-56CE59632E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0348-816D-BB46-AFBB-38E640A4E6AD}" type="datetimeFigureOut">
              <a:rPr kumimoji="1" lang="ja-JP" altLang="en-US" smtClean="0"/>
              <a:t>2026/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A44DF42-3DE8-45EA-C5D3-D135D33BBF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9E570D4-F932-DBE2-C07F-B64D7FE9E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6210-0803-F845-8C25-9090BCE3B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2534283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40318" y="457200"/>
            <a:ext cx="393276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717" y="987426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40318" y="2057400"/>
            <a:ext cx="393276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fld id="{C8D0BA26-4D8C-44B0-83E2-048BBE1D326D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07854235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fld id="{EE7CD798-2997-4F10-9712-37CB9849C9C7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58997511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9025467" y="404813"/>
            <a:ext cx="2927351" cy="5688012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39184" y="404813"/>
            <a:ext cx="8583083" cy="5688012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fld id="{61F71607-44E9-4457-B0D3-E90725091B13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984301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227318F-BB6D-6F71-179D-A44112A4E5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19887CB-4E4E-2968-0CCB-978F4FF7AE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76D795F-E40B-8334-17BE-F1F3E14527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0348-816D-BB46-AFBB-38E640A4E6AD}" type="datetimeFigureOut">
              <a:rPr kumimoji="1" lang="ja-JP" altLang="en-US" smtClean="0"/>
              <a:t>2026/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6C7395E-76AB-BD37-4A9C-2C755E0A15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57B987B-FB70-CA04-9B20-57CED33DA5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6210-0803-F845-8C25-9090BCE3B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681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9D9E86E-1A6E-F0A8-A751-84A390596C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2394621-D101-DC59-FAD4-6DFF6DD21A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38390B0-2E47-F0D8-3F5F-3FFD2138D9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7A47FDA-F804-1BC1-2ACC-C7ACE9F11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0348-816D-BB46-AFBB-38E640A4E6AD}" type="datetimeFigureOut">
              <a:rPr kumimoji="1" lang="ja-JP" altLang="en-US" smtClean="0"/>
              <a:t>2026/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4308076-6E70-A305-5A86-DCB9D0100E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184D75B-CC99-43A1-2660-29DFE78A6A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6210-0803-F845-8C25-9090BCE3B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3214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4BA09FE-C5C0-C54F-8E8E-E88D9FC239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B50E37A-DA3D-6A87-566A-FBF201E4DF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CA1C371-3BF3-0F1F-0DF7-35CECF9F48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F1FDFDE-7F83-135D-5A3A-58AC9F8315B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A639EB7-F14B-CE39-37D5-1D060C8CBB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F29F47E-7D75-55B9-3174-FAFECA8A4B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0348-816D-BB46-AFBB-38E640A4E6AD}" type="datetimeFigureOut">
              <a:rPr kumimoji="1" lang="ja-JP" altLang="en-US" smtClean="0"/>
              <a:t>2026/2/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A03DDAD-9922-BDA9-6AD0-EEB9938C03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DF8E51B-14D3-1182-28EC-81F6E17948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6210-0803-F845-8C25-9090BCE3B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24229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DBB327-0E60-B36E-3DC0-5E53054E9F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86A642E-DEFB-CEB0-71A4-22DA32E717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0348-816D-BB46-AFBB-38E640A4E6AD}" type="datetimeFigureOut">
              <a:rPr kumimoji="1" lang="ja-JP" altLang="en-US" smtClean="0"/>
              <a:t>2026/2/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6731333-B86F-69B3-4562-23865E181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C3BE1961-F494-56B1-8888-13125211F5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6210-0803-F845-8C25-9090BCE3B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9162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98AA375-27CC-658A-8B53-0CC320FD90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0348-816D-BB46-AFBB-38E640A4E6AD}" type="datetimeFigureOut">
              <a:rPr kumimoji="1" lang="ja-JP" altLang="en-US" smtClean="0"/>
              <a:t>2026/2/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0B4B208-E844-245F-261A-CE98BA20A6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F57F14F-07B9-EBF8-C274-A6AB2FD9E8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6210-0803-F845-8C25-9090BCE3B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1645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B437AD-D024-0CCA-3192-A182A9B41A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25E149A-B59D-7736-1BCC-FA58D4A23B2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44E6F4F-D999-09F9-D0B4-4400A6F186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64265D2-D3AC-392F-E97B-5176FEB64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0348-816D-BB46-AFBB-38E640A4E6AD}" type="datetimeFigureOut">
              <a:rPr kumimoji="1" lang="ja-JP" altLang="en-US" smtClean="0"/>
              <a:t>2026/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9CA7178-AB32-AB57-9618-1ECBB8B111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11912E7-6765-AE6F-2D65-860441DDBD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6210-0803-F845-8C25-9090BCE3B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7740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C6B88FF-D7E7-9FBE-9BE6-B496F9B56E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ACC6A91-E3E7-C0BB-4082-E557B5AACA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EFC1F75-A653-FD15-093C-8E1FC19F19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1010431-2FAF-570E-F7FB-B1F668AAD1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30348-816D-BB46-AFBB-38E640A4E6AD}" type="datetimeFigureOut">
              <a:rPr kumimoji="1" lang="ja-JP" altLang="en-US" smtClean="0"/>
              <a:t>2026/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03C98E2-5E98-20AD-83D2-492F5BABA1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06762F4-DE39-C1BB-3084-0F065EDEF0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56210-0803-F845-8C25-9090BCE3B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6419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C3BC46B-E766-8FCB-B6D3-516C80D47B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223D827-5D12-6DCF-5264-5B54CADBCB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2BC979F-BF4B-2794-89C4-F9D7D952B02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430348-816D-BB46-AFBB-38E640A4E6AD}" type="datetimeFigureOut">
              <a:rPr kumimoji="1" lang="ja-JP" altLang="en-US" smtClean="0"/>
              <a:t>2026/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ACA0603-5408-C512-1EB9-A5C6F88843C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968EE65-3C28-80C1-2E1B-DAA0465DA7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F56210-0803-F845-8C25-9090BCE3BC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4996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74" name="Rectangle 10"/>
          <p:cNvSpPr>
            <a:spLocks noChangeArrowheads="1"/>
          </p:cNvSpPr>
          <p:nvPr/>
        </p:nvSpPr>
        <p:spPr bwMode="auto">
          <a:xfrm>
            <a:off x="0" y="908051"/>
            <a:ext cx="12192000" cy="73025"/>
          </a:xfrm>
          <a:prstGeom prst="rect">
            <a:avLst/>
          </a:prstGeom>
          <a:solidFill>
            <a:srgbClr val="9CB66D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endParaRPr lang="ja-JP" altLang="ja-JP" sz="1800"/>
          </a:p>
        </p:txBody>
      </p:sp>
      <p:sp>
        <p:nvSpPr>
          <p:cNvPr id="11271" name="Rectangle 7"/>
          <p:cNvSpPr>
            <a:spLocks noChangeArrowheads="1"/>
          </p:cNvSpPr>
          <p:nvPr/>
        </p:nvSpPr>
        <p:spPr bwMode="auto">
          <a:xfrm>
            <a:off x="0" y="0"/>
            <a:ext cx="12192000" cy="908050"/>
          </a:xfrm>
          <a:prstGeom prst="rect">
            <a:avLst/>
          </a:prstGeom>
          <a:solidFill>
            <a:srgbClr val="23651C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endParaRPr lang="ja-JP" altLang="ja-JP" sz="1800"/>
          </a:p>
        </p:txBody>
      </p:sp>
      <p:sp>
        <p:nvSpPr>
          <p:cNvPr id="1126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239184" y="404814"/>
            <a:ext cx="10081683" cy="5095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126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239185" y="1125538"/>
            <a:ext cx="11713633" cy="49672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127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10979151" y="44450"/>
            <a:ext cx="1068916" cy="4841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2400">
                <a:solidFill>
                  <a:schemeClr val="bg1"/>
                </a:solidFill>
              </a:defRPr>
            </a:lvl1pPr>
          </a:lstStyle>
          <a:p>
            <a:fld id="{4608D3C7-E4B7-4A14-8A8B-F260EA7B2EDD}" type="slidenum">
              <a:rPr lang="en-US" altLang="ja-JP"/>
              <a:pPr/>
              <a:t>‹#›</a:t>
            </a:fld>
            <a:endParaRPr lang="en-US" altLang="ja-JP"/>
          </a:p>
        </p:txBody>
      </p:sp>
      <p:sp>
        <p:nvSpPr>
          <p:cNvPr id="11275" name="Rectangle 11"/>
          <p:cNvSpPr>
            <a:spLocks noChangeArrowheads="1"/>
          </p:cNvSpPr>
          <p:nvPr/>
        </p:nvSpPr>
        <p:spPr bwMode="auto">
          <a:xfrm>
            <a:off x="0" y="6165851"/>
            <a:ext cx="12192000" cy="695325"/>
          </a:xfrm>
          <a:prstGeom prst="rect">
            <a:avLst/>
          </a:prstGeom>
          <a:solidFill>
            <a:srgbClr val="DDDDDD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endParaRPr lang="ja-JP" altLang="ja-JP" sz="1800"/>
          </a:p>
        </p:txBody>
      </p:sp>
      <p:pic>
        <p:nvPicPr>
          <p:cNvPr id="11276" name="Picture 12" descr="logomark1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74305" y="6188075"/>
            <a:ext cx="2378511" cy="647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278" name="Text Box 14"/>
          <p:cNvSpPr txBox="1">
            <a:spLocks noChangeArrowheads="1"/>
          </p:cNvSpPr>
          <p:nvPr/>
        </p:nvSpPr>
        <p:spPr bwMode="auto">
          <a:xfrm>
            <a:off x="5685367" y="-282575"/>
            <a:ext cx="4155017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l"/>
            <a:endParaRPr lang="ja-JP" altLang="ja-JP" sz="1800"/>
          </a:p>
        </p:txBody>
      </p:sp>
    </p:spTree>
    <p:extLst>
      <p:ext uri="{BB962C8B-B14F-4D97-AF65-F5344CB8AC3E}">
        <p14:creationId xmlns:p14="http://schemas.microsoft.com/office/powerpoint/2010/main" val="3598101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rtl="0" eaLnBrk="1" fontAlgn="base" hangingPunct="1">
        <a:spcBef>
          <a:spcPct val="0"/>
        </a:spcBef>
        <a:spcAft>
          <a:spcPct val="0"/>
        </a:spcAft>
        <a:defRPr kumimoji="1" sz="2400" kern="1200">
          <a:solidFill>
            <a:schemeClr val="bg1"/>
          </a:solidFill>
          <a:latin typeface="+mj-lt"/>
          <a:ea typeface="+mj-ea"/>
          <a:cs typeface="+mj-cs"/>
        </a:defRPr>
      </a:lvl1pPr>
      <a:lvl2pPr algn="l" rtl="0" eaLnBrk="1" fontAlgn="base" hangingPunct="1">
        <a:spcBef>
          <a:spcPct val="0"/>
        </a:spcBef>
        <a:spcAft>
          <a:spcPct val="0"/>
        </a:spcAft>
        <a:defRPr kumimoji="1" sz="2400">
          <a:solidFill>
            <a:schemeClr val="bg1"/>
          </a:solidFill>
          <a:latin typeface="Arial" panose="020B0604020202020204" pitchFamily="34" charset="0"/>
          <a:ea typeface="ＭＳ Ｐゴシック" panose="020B0600070205080204" pitchFamily="50" charset="-128"/>
        </a:defRPr>
      </a:lvl2pPr>
      <a:lvl3pPr algn="l" rtl="0" eaLnBrk="1" fontAlgn="base" hangingPunct="1">
        <a:spcBef>
          <a:spcPct val="0"/>
        </a:spcBef>
        <a:spcAft>
          <a:spcPct val="0"/>
        </a:spcAft>
        <a:defRPr kumimoji="1" sz="2400">
          <a:solidFill>
            <a:schemeClr val="bg1"/>
          </a:solidFill>
          <a:latin typeface="Arial" panose="020B0604020202020204" pitchFamily="34" charset="0"/>
          <a:ea typeface="ＭＳ Ｐゴシック" panose="020B0600070205080204" pitchFamily="50" charset="-128"/>
        </a:defRPr>
      </a:lvl3pPr>
      <a:lvl4pPr algn="l" rtl="0" eaLnBrk="1" fontAlgn="base" hangingPunct="1">
        <a:spcBef>
          <a:spcPct val="0"/>
        </a:spcBef>
        <a:spcAft>
          <a:spcPct val="0"/>
        </a:spcAft>
        <a:defRPr kumimoji="1" sz="2400">
          <a:solidFill>
            <a:schemeClr val="bg1"/>
          </a:solidFill>
          <a:latin typeface="Arial" panose="020B0604020202020204" pitchFamily="34" charset="0"/>
          <a:ea typeface="ＭＳ Ｐゴシック" panose="020B0600070205080204" pitchFamily="50" charset="-128"/>
        </a:defRPr>
      </a:lvl4pPr>
      <a:lvl5pPr algn="l" rtl="0" eaLnBrk="1" fontAlgn="base" hangingPunct="1">
        <a:spcBef>
          <a:spcPct val="0"/>
        </a:spcBef>
        <a:spcAft>
          <a:spcPct val="0"/>
        </a:spcAft>
        <a:defRPr kumimoji="1" sz="2400">
          <a:solidFill>
            <a:schemeClr val="bg1"/>
          </a:solidFill>
          <a:latin typeface="Arial" panose="020B0604020202020204" pitchFamily="34" charset="0"/>
          <a:ea typeface="ＭＳ Ｐゴシック" panose="020B0600070205080204" pitchFamily="50" charset="-128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kumimoji="1" sz="2400">
          <a:solidFill>
            <a:schemeClr val="bg1"/>
          </a:solidFill>
          <a:latin typeface="Arial" panose="020B0604020202020204" pitchFamily="34" charset="0"/>
          <a:ea typeface="ＭＳ Ｐゴシック" panose="020B0600070205080204" pitchFamily="50" charset="-128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kumimoji="1" sz="2400">
          <a:solidFill>
            <a:schemeClr val="bg1"/>
          </a:solidFill>
          <a:latin typeface="Arial" panose="020B0604020202020204" pitchFamily="34" charset="0"/>
          <a:ea typeface="ＭＳ Ｐゴシック" panose="020B0600070205080204" pitchFamily="50" charset="-128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kumimoji="1" sz="2400">
          <a:solidFill>
            <a:schemeClr val="bg1"/>
          </a:solidFill>
          <a:latin typeface="Arial" panose="020B0604020202020204" pitchFamily="34" charset="0"/>
          <a:ea typeface="ＭＳ Ｐゴシック" panose="020B0600070205080204" pitchFamily="50" charset="-128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kumimoji="1" sz="2400">
          <a:solidFill>
            <a:schemeClr val="bg1"/>
          </a:solidFill>
          <a:latin typeface="Arial" panose="020B0604020202020204" pitchFamily="34" charset="0"/>
          <a:ea typeface="ＭＳ Ｐゴシック" panose="020B0600070205080204" pitchFamily="50" charset="-128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Char char="–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CD6BAAB-0480-86D5-156E-74202ADEBD8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BCAE22-FA56-35D8-E47A-ACF3237AC2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65125"/>
            <a:ext cx="11353800" cy="792745"/>
          </a:xfrm>
        </p:spPr>
        <p:txBody>
          <a:bodyPr/>
          <a:lstStyle/>
          <a:p>
            <a:r>
              <a:rPr lang="en-US" altLang="ja-JP" sz="3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kumimoji="1" lang="ja-JP" altLang="en-US" sz="32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1EEFDCA5-CA55-F063-C8F8-D0FC3996F72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8263" t="18637" r="8124" b="5277"/>
          <a:stretch>
            <a:fillRect/>
          </a:stretch>
        </p:blipFill>
        <p:spPr>
          <a:xfrm>
            <a:off x="738353" y="965845"/>
            <a:ext cx="10615447" cy="54335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64341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6226074-B302-509A-0BF5-47D61F014E2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39ABE412-0C3C-910E-CC39-BFDB04F4169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0987" t="11162" r="46824" b="41995"/>
          <a:stretch>
            <a:fillRect/>
          </a:stretch>
        </p:blipFill>
        <p:spPr>
          <a:xfrm>
            <a:off x="1112894" y="1625173"/>
            <a:ext cx="3165236" cy="3758775"/>
          </a:xfrm>
          <a:prstGeom prst="rect">
            <a:avLst/>
          </a:prstGeom>
        </p:spPr>
      </p:pic>
      <p:sp>
        <p:nvSpPr>
          <p:cNvPr id="2" name="タイトル 1">
            <a:extLst>
              <a:ext uri="{FF2B5EF4-FFF2-40B4-BE49-F238E27FC236}">
                <a16:creationId xmlns:a16="http://schemas.microsoft.com/office/drawing/2014/main" id="{A9812D78-2131-BBD9-2A9D-DE57AF91CF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65125"/>
            <a:ext cx="11353800" cy="792745"/>
          </a:xfrm>
        </p:spPr>
        <p:txBody>
          <a:bodyPr/>
          <a:lstStyle/>
          <a:p>
            <a:r>
              <a:rPr lang="en-US" altLang="ja-JP" sz="3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  <a:endParaRPr kumimoji="1" lang="ja-JP" altLang="en-US" sz="32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E5898883-49DD-BBB7-1177-5AA3A1A9D54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53464" t="11162" r="21564" b="66108"/>
          <a:stretch>
            <a:fillRect/>
          </a:stretch>
        </p:blipFill>
        <p:spPr>
          <a:xfrm>
            <a:off x="3801538" y="1157870"/>
            <a:ext cx="2340220" cy="1198183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909E095-AF5A-157C-B7C7-BF12E7974475}"/>
              </a:ext>
            </a:extLst>
          </p:cNvPr>
          <p:cNvSpPr txBox="1"/>
          <p:nvPr/>
        </p:nvSpPr>
        <p:spPr>
          <a:xfrm>
            <a:off x="1661513" y="5347717"/>
            <a:ext cx="125863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Early </a:t>
            </a:r>
          </a:p>
          <a:p>
            <a:pPr algn="ctr"/>
            <a:r>
              <a:rPr kumimoji="1" lang="en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HCC</a:t>
            </a:r>
          </a:p>
          <a:p>
            <a:pPr algn="ctr"/>
            <a:r>
              <a:rPr kumimoji="1" lang="en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BCLC 0,A)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F1E4955-2C5E-50BE-21AC-E45ACC7C516F}"/>
              </a:ext>
            </a:extLst>
          </p:cNvPr>
          <p:cNvSpPr txBox="1"/>
          <p:nvPr/>
        </p:nvSpPr>
        <p:spPr>
          <a:xfrm>
            <a:off x="2718960" y="5347717"/>
            <a:ext cx="122821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dvanced</a:t>
            </a:r>
            <a:r>
              <a:rPr kumimoji="1" lang="en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kumimoji="1" lang="en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HCC</a:t>
            </a:r>
          </a:p>
          <a:p>
            <a:pPr algn="ctr"/>
            <a:r>
              <a:rPr lang="en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BCLC B,C)</a:t>
            </a:r>
            <a:endParaRPr kumimoji="1"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7016C07-FDB8-C05B-6F70-B84847F1DAC9}"/>
              </a:ext>
            </a:extLst>
          </p:cNvPr>
          <p:cNvSpPr txBox="1"/>
          <p:nvPr/>
        </p:nvSpPr>
        <p:spPr>
          <a:xfrm rot="16200000" flipH="1">
            <a:off x="-147566" y="3244334"/>
            <a:ext cx="23408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roportion (%)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4E7B700-47A6-F514-8523-16375D504DC3}"/>
              </a:ext>
            </a:extLst>
          </p:cNvPr>
          <p:cNvSpPr txBox="1"/>
          <p:nvPr/>
        </p:nvSpPr>
        <p:spPr>
          <a:xfrm>
            <a:off x="1755792" y="6108345"/>
            <a:ext cx="10574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= 123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A1AFE12-40DD-A833-EC06-CB44310E997D}"/>
              </a:ext>
            </a:extLst>
          </p:cNvPr>
          <p:cNvSpPr txBox="1"/>
          <p:nvPr/>
        </p:nvSpPr>
        <p:spPr>
          <a:xfrm>
            <a:off x="2938505" y="6108345"/>
            <a:ext cx="7889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= 65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E49B627-35F4-918D-9B4E-8E1620832EEC}"/>
              </a:ext>
            </a:extLst>
          </p:cNvPr>
          <p:cNvSpPr txBox="1"/>
          <p:nvPr/>
        </p:nvSpPr>
        <p:spPr>
          <a:xfrm>
            <a:off x="644594" y="1202963"/>
            <a:ext cx="5866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左大かっこ 15">
            <a:extLst>
              <a:ext uri="{FF2B5EF4-FFF2-40B4-BE49-F238E27FC236}">
                <a16:creationId xmlns:a16="http://schemas.microsoft.com/office/drawing/2014/main" id="{B691B249-C810-286C-B2E9-C48BB80CA860}"/>
              </a:ext>
            </a:extLst>
          </p:cNvPr>
          <p:cNvSpPr/>
          <p:nvPr/>
        </p:nvSpPr>
        <p:spPr>
          <a:xfrm rot="5400000">
            <a:off x="2686836" y="1176291"/>
            <a:ext cx="256505" cy="1048512"/>
          </a:xfrm>
          <a:prstGeom prst="leftBracket">
            <a:avLst>
              <a:gd name="adj" fmla="val 0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61121AF-87BA-159F-4259-439965EADE4B}"/>
              </a:ext>
            </a:extLst>
          </p:cNvPr>
          <p:cNvSpPr txBox="1"/>
          <p:nvPr/>
        </p:nvSpPr>
        <p:spPr>
          <a:xfrm>
            <a:off x="2218853" y="1202961"/>
            <a:ext cx="11826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 = 0.097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図 19">
            <a:extLst>
              <a:ext uri="{FF2B5EF4-FFF2-40B4-BE49-F238E27FC236}">
                <a16:creationId xmlns:a16="http://schemas.microsoft.com/office/drawing/2014/main" id="{DF318202-849B-FF25-90E1-974C5CF7F0D3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3741" t="10330" r="50000" b="34733"/>
          <a:stretch>
            <a:fillRect/>
          </a:stretch>
        </p:blipFill>
        <p:spPr>
          <a:xfrm>
            <a:off x="6835125" y="1425647"/>
            <a:ext cx="3363633" cy="3958300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6012ECBA-197F-8919-4C0D-1772EA37AD1B}"/>
              </a:ext>
            </a:extLst>
          </p:cNvPr>
          <p:cNvSpPr txBox="1"/>
          <p:nvPr/>
        </p:nvSpPr>
        <p:spPr>
          <a:xfrm rot="16200000" flipH="1">
            <a:off x="5700103" y="3244334"/>
            <a:ext cx="23408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roportion (%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08F09B8-EFB8-54AF-24FF-F2BF644A72A3}"/>
              </a:ext>
            </a:extLst>
          </p:cNvPr>
          <p:cNvSpPr txBox="1"/>
          <p:nvPr/>
        </p:nvSpPr>
        <p:spPr>
          <a:xfrm>
            <a:off x="6541820" y="1202961"/>
            <a:ext cx="5866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図 21">
            <a:extLst>
              <a:ext uri="{FF2B5EF4-FFF2-40B4-BE49-F238E27FC236}">
                <a16:creationId xmlns:a16="http://schemas.microsoft.com/office/drawing/2014/main" id="{AB1EC772-BFB5-4E59-B2F6-696F45F49F8E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53464" t="11162" r="21564" b="66108"/>
          <a:stretch>
            <a:fillRect/>
          </a:stretch>
        </p:blipFill>
        <p:spPr>
          <a:xfrm>
            <a:off x="9685425" y="1202961"/>
            <a:ext cx="2340220" cy="1198183"/>
          </a:xfrm>
          <a:prstGeom prst="rect">
            <a:avLst/>
          </a:prstGeom>
        </p:spPr>
      </p:pic>
      <p:sp>
        <p:nvSpPr>
          <p:cNvPr id="23" name="左大かっこ 22">
            <a:extLst>
              <a:ext uri="{FF2B5EF4-FFF2-40B4-BE49-F238E27FC236}">
                <a16:creationId xmlns:a16="http://schemas.microsoft.com/office/drawing/2014/main" id="{2DC7E8E9-5469-7313-3297-6C2A78362DD3}"/>
              </a:ext>
            </a:extLst>
          </p:cNvPr>
          <p:cNvSpPr/>
          <p:nvPr/>
        </p:nvSpPr>
        <p:spPr>
          <a:xfrm rot="5400000">
            <a:off x="8570501" y="1131018"/>
            <a:ext cx="256505" cy="1048512"/>
          </a:xfrm>
          <a:prstGeom prst="leftBracket">
            <a:avLst>
              <a:gd name="adj" fmla="val 0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22EBCDF-8AE8-8F6A-F85C-265EE317224D}"/>
              </a:ext>
            </a:extLst>
          </p:cNvPr>
          <p:cNvSpPr txBox="1"/>
          <p:nvPr/>
        </p:nvSpPr>
        <p:spPr>
          <a:xfrm>
            <a:off x="7105635" y="6221239"/>
            <a:ext cx="3186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dvanced HCC (BCLC B,C)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451B8E4F-1AD1-2569-18AF-A85797CB6432}"/>
              </a:ext>
            </a:extLst>
          </p:cNvPr>
          <p:cNvSpPr txBox="1"/>
          <p:nvPr/>
        </p:nvSpPr>
        <p:spPr>
          <a:xfrm>
            <a:off x="7560390" y="5347717"/>
            <a:ext cx="122821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No systemic therapy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3B35D2FF-DC1D-835E-CEB1-21067CB93130}"/>
              </a:ext>
            </a:extLst>
          </p:cNvPr>
          <p:cNvSpPr txBox="1"/>
          <p:nvPr/>
        </p:nvSpPr>
        <p:spPr>
          <a:xfrm>
            <a:off x="8698753" y="5347717"/>
            <a:ext cx="104851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ystemic therapy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63BB38D-C4CC-A324-B6B6-9C6E79925ED1}"/>
              </a:ext>
            </a:extLst>
          </p:cNvPr>
          <p:cNvSpPr txBox="1"/>
          <p:nvPr/>
        </p:nvSpPr>
        <p:spPr>
          <a:xfrm>
            <a:off x="7699554" y="5876811"/>
            <a:ext cx="9631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= 42</a:t>
            </a:r>
            <a:endParaRPr kumimoji="1"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32144514-5C43-F8A7-086E-FCC132810371}"/>
              </a:ext>
            </a:extLst>
          </p:cNvPr>
          <p:cNvSpPr txBox="1"/>
          <p:nvPr/>
        </p:nvSpPr>
        <p:spPr>
          <a:xfrm>
            <a:off x="8722257" y="5870937"/>
            <a:ext cx="9631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= 23</a:t>
            </a:r>
            <a:endParaRPr kumimoji="1"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973F1BD-4E2C-5221-D5C7-6C9CFA490464}"/>
              </a:ext>
            </a:extLst>
          </p:cNvPr>
          <p:cNvSpPr txBox="1"/>
          <p:nvPr/>
        </p:nvSpPr>
        <p:spPr>
          <a:xfrm>
            <a:off x="8107441" y="1157870"/>
            <a:ext cx="11826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 = 0.912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94285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0C11A05-2BC1-9E1C-53A5-86F0BEC6021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733AC448-6EED-22F1-5B11-A9C703AAE6F4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4721" t="12123" r="51095" b="33820"/>
          <a:stretch>
            <a:fillRect/>
          </a:stretch>
        </p:blipFill>
        <p:spPr>
          <a:xfrm>
            <a:off x="2063750" y="1626867"/>
            <a:ext cx="3011983" cy="3786986"/>
          </a:xfrm>
          <a:prstGeom prst="rect">
            <a:avLst/>
          </a:prstGeom>
        </p:spPr>
      </p:pic>
      <p:sp>
        <p:nvSpPr>
          <p:cNvPr id="2" name="タイトル 1">
            <a:extLst>
              <a:ext uri="{FF2B5EF4-FFF2-40B4-BE49-F238E27FC236}">
                <a16:creationId xmlns:a16="http://schemas.microsoft.com/office/drawing/2014/main" id="{6922906A-8E3B-A1B3-5725-392F49DA45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65125"/>
            <a:ext cx="11353800" cy="792745"/>
          </a:xfrm>
        </p:spPr>
        <p:txBody>
          <a:bodyPr/>
          <a:lstStyle/>
          <a:p>
            <a:r>
              <a:rPr lang="en-US" altLang="ja-JP" sz="3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  <a:endParaRPr kumimoji="1" lang="ja-JP" altLang="en-US" sz="32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053AD23-F02E-BAED-C0C9-F217DCF39413}"/>
              </a:ext>
            </a:extLst>
          </p:cNvPr>
          <p:cNvSpPr txBox="1"/>
          <p:nvPr/>
        </p:nvSpPr>
        <p:spPr>
          <a:xfrm rot="16200000" flipH="1">
            <a:off x="832540" y="3281279"/>
            <a:ext cx="23408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roportion (%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7613D69-5E8E-6F4A-E302-4006A46FB2FD}"/>
              </a:ext>
            </a:extLst>
          </p:cNvPr>
          <p:cNvSpPr txBox="1"/>
          <p:nvPr/>
        </p:nvSpPr>
        <p:spPr>
          <a:xfrm>
            <a:off x="1674257" y="1239906"/>
            <a:ext cx="5866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図 21">
            <a:extLst>
              <a:ext uri="{FF2B5EF4-FFF2-40B4-BE49-F238E27FC236}">
                <a16:creationId xmlns:a16="http://schemas.microsoft.com/office/drawing/2014/main" id="{4B13F4BD-364E-93AD-823D-DB67469E40A7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53464" t="11162" r="21564" b="66108"/>
          <a:stretch>
            <a:fillRect/>
          </a:stretch>
        </p:blipFill>
        <p:spPr>
          <a:xfrm>
            <a:off x="4817862" y="1239906"/>
            <a:ext cx="2340220" cy="1198183"/>
          </a:xfrm>
          <a:prstGeom prst="rect">
            <a:avLst/>
          </a:prstGeom>
        </p:spPr>
      </p:pic>
      <p:sp>
        <p:nvSpPr>
          <p:cNvPr id="23" name="左大かっこ 22">
            <a:extLst>
              <a:ext uri="{FF2B5EF4-FFF2-40B4-BE49-F238E27FC236}">
                <a16:creationId xmlns:a16="http://schemas.microsoft.com/office/drawing/2014/main" id="{9D128ADD-2689-6A8B-8C6D-06D45E17BA33}"/>
              </a:ext>
            </a:extLst>
          </p:cNvPr>
          <p:cNvSpPr/>
          <p:nvPr/>
        </p:nvSpPr>
        <p:spPr>
          <a:xfrm rot="5400000">
            <a:off x="3702938" y="1167963"/>
            <a:ext cx="256505" cy="1048512"/>
          </a:xfrm>
          <a:prstGeom prst="leftBracket">
            <a:avLst>
              <a:gd name="adj" fmla="val 0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EEA7404B-3E80-F1FE-457A-65C106727AE0}"/>
              </a:ext>
            </a:extLst>
          </p:cNvPr>
          <p:cNvSpPr txBox="1"/>
          <p:nvPr/>
        </p:nvSpPr>
        <p:spPr>
          <a:xfrm>
            <a:off x="2654421" y="5367924"/>
            <a:ext cx="131830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No systemic therapy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159B095A-47BC-FD79-8ECF-033A756B7CB3}"/>
              </a:ext>
            </a:extLst>
          </p:cNvPr>
          <p:cNvSpPr txBox="1"/>
          <p:nvPr/>
        </p:nvSpPr>
        <p:spPr>
          <a:xfrm>
            <a:off x="3900806" y="5378230"/>
            <a:ext cx="8709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MKI therapy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608C35B0-BFA1-582B-9BC4-841A9BEECE00}"/>
              </a:ext>
            </a:extLst>
          </p:cNvPr>
          <p:cNvSpPr txBox="1"/>
          <p:nvPr/>
        </p:nvSpPr>
        <p:spPr>
          <a:xfrm>
            <a:off x="2831991" y="5897018"/>
            <a:ext cx="9631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= 42</a:t>
            </a:r>
            <a:endParaRPr kumimoji="1"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AB4B6728-8BB1-0DA8-6AC1-D113FE83B4BB}"/>
              </a:ext>
            </a:extLst>
          </p:cNvPr>
          <p:cNvSpPr txBox="1"/>
          <p:nvPr/>
        </p:nvSpPr>
        <p:spPr>
          <a:xfrm>
            <a:off x="3854694" y="5891144"/>
            <a:ext cx="9631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= 21</a:t>
            </a:r>
            <a:endParaRPr kumimoji="1"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BB4EFC57-3263-AF5A-24E4-02CD034814F6}"/>
              </a:ext>
            </a:extLst>
          </p:cNvPr>
          <p:cNvSpPr txBox="1"/>
          <p:nvPr/>
        </p:nvSpPr>
        <p:spPr>
          <a:xfrm>
            <a:off x="3239878" y="1194815"/>
            <a:ext cx="11826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 = 0.669 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7AE5973-0612-35CC-E7C8-CB47462CC256}"/>
              </a:ext>
            </a:extLst>
          </p:cNvPr>
          <p:cNvSpPr txBox="1"/>
          <p:nvPr/>
        </p:nvSpPr>
        <p:spPr>
          <a:xfrm>
            <a:off x="2238072" y="6258184"/>
            <a:ext cx="3186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dvanced HCC (BCLC B,C)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66057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22519CD-1D92-B989-6CC1-7CC85D73018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>
            <a:extLst>
              <a:ext uri="{FF2B5EF4-FFF2-40B4-BE49-F238E27FC236}">
                <a16:creationId xmlns:a16="http://schemas.microsoft.com/office/drawing/2014/main" id="{27DC9DF9-E162-26D4-315B-EE6001A3A2D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672" t="18195" r="9704" b="9933"/>
          <a:stretch>
            <a:fillRect/>
          </a:stretch>
        </p:blipFill>
        <p:spPr>
          <a:xfrm>
            <a:off x="6281185" y="3753555"/>
            <a:ext cx="5878671" cy="3013711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0E04DEB0-76B6-3959-B338-DF155465DDF7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538" t="19489" r="9556" b="8076"/>
          <a:stretch>
            <a:fillRect/>
          </a:stretch>
        </p:blipFill>
        <p:spPr>
          <a:xfrm>
            <a:off x="335721" y="3806139"/>
            <a:ext cx="5921136" cy="3015153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08C66719-329A-69BD-DC4D-0E73C003C08D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445" t="17825" r="8927" b="10588"/>
          <a:stretch>
            <a:fillRect/>
          </a:stretch>
        </p:blipFill>
        <p:spPr>
          <a:xfrm>
            <a:off x="6164561" y="577406"/>
            <a:ext cx="5904405" cy="2947460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3B5D2827-519E-8870-D45D-8B74A655D28E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3299" t="19241" r="13105" b="9597"/>
          <a:stretch>
            <a:fillRect/>
          </a:stretch>
        </p:blipFill>
        <p:spPr>
          <a:xfrm>
            <a:off x="484402" y="758184"/>
            <a:ext cx="5543039" cy="2949115"/>
          </a:xfrm>
          <a:prstGeom prst="rect">
            <a:avLst/>
          </a:prstGeom>
        </p:spPr>
      </p:pic>
      <p:sp>
        <p:nvSpPr>
          <p:cNvPr id="2" name="タイトル 1">
            <a:extLst>
              <a:ext uri="{FF2B5EF4-FFF2-40B4-BE49-F238E27FC236}">
                <a16:creationId xmlns:a16="http://schemas.microsoft.com/office/drawing/2014/main" id="{CD1180CB-B22A-5BEE-67E5-268B332A82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1353800" cy="792745"/>
          </a:xfrm>
        </p:spPr>
        <p:txBody>
          <a:bodyPr/>
          <a:lstStyle/>
          <a:p>
            <a:r>
              <a:rPr lang="en-US" altLang="ja-JP" sz="3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  <a:endParaRPr kumimoji="1" lang="ja-JP" altLang="en-US" sz="32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E8B5247-FC7C-9819-C38F-4C6D40C24B66}"/>
              </a:ext>
            </a:extLst>
          </p:cNvPr>
          <p:cNvSpPr txBox="1"/>
          <p:nvPr/>
        </p:nvSpPr>
        <p:spPr>
          <a:xfrm>
            <a:off x="6076097" y="577406"/>
            <a:ext cx="683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30FD848-13C2-91E5-44FA-991C3186DDE7}"/>
              </a:ext>
            </a:extLst>
          </p:cNvPr>
          <p:cNvSpPr txBox="1"/>
          <p:nvPr/>
        </p:nvSpPr>
        <p:spPr>
          <a:xfrm>
            <a:off x="230658" y="685076"/>
            <a:ext cx="5866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2C57EB5-D00C-C308-094D-5F8C2DB27BD1}"/>
              </a:ext>
            </a:extLst>
          </p:cNvPr>
          <p:cNvSpPr txBox="1"/>
          <p:nvPr/>
        </p:nvSpPr>
        <p:spPr>
          <a:xfrm>
            <a:off x="182002" y="3652146"/>
            <a:ext cx="683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D5EA5FA-4E62-72B3-2440-F1D52780E106}"/>
              </a:ext>
            </a:extLst>
          </p:cNvPr>
          <p:cNvSpPr txBox="1"/>
          <p:nvPr/>
        </p:nvSpPr>
        <p:spPr>
          <a:xfrm>
            <a:off x="6076097" y="3652146"/>
            <a:ext cx="683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33569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ppt1j">
  <a:themeElements>
    <a:clrScheme name="ppt1j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ppt1j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anose="020B0604020202020204" pitchFamily="34" charset="0"/>
            <a:ea typeface="ＭＳ Ｐゴシック" panose="020B0600070205080204" pitchFamily="50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anose="020B0604020202020204" pitchFamily="34" charset="0"/>
            <a:ea typeface="ＭＳ Ｐゴシック" panose="020B0600070205080204" pitchFamily="50" charset="-128"/>
          </a:defRPr>
        </a:defPPr>
      </a:lstStyle>
    </a:lnDef>
  </a:objectDefaults>
  <a:extraClrSchemeLst>
    <a:extraClrScheme>
      <a:clrScheme name="ppt1j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pt1j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pt1j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pt1j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pt1j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pt1j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pt1j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pt1j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pt1j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pt1j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pt1j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pt1j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2</TotalTime>
  <Words>124</Words>
  <Application>Microsoft Macintosh PowerPoint</Application>
  <PresentationFormat>ワイド画面</PresentationFormat>
  <Paragraphs>40</Paragraphs>
  <Slides>4</Slides>
  <Notes>4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游ゴシック</vt:lpstr>
      <vt:lpstr>游ゴシック Light</vt:lpstr>
      <vt:lpstr>Arial</vt:lpstr>
      <vt:lpstr>Office テーマ</vt:lpstr>
      <vt:lpstr>ppt1j</vt:lpstr>
      <vt:lpstr>Fig. S1</vt:lpstr>
      <vt:lpstr>Fig. S2</vt:lpstr>
      <vt:lpstr>Fig. S2</vt:lpstr>
      <vt:lpstr>Fig. S3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崇倫 田中</dc:creator>
  <cp:lastModifiedBy>崇倫 田中</cp:lastModifiedBy>
  <cp:revision>112</cp:revision>
  <dcterms:created xsi:type="dcterms:W3CDTF">2025-02-26T11:40:06Z</dcterms:created>
  <dcterms:modified xsi:type="dcterms:W3CDTF">2026-02-05T11:59:22Z</dcterms:modified>
</cp:coreProperties>
</file>